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7" r:id="rId2"/>
    <p:sldId id="260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87" d="100"/>
          <a:sy n="87" d="100"/>
        </p:scale>
        <p:origin x="64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F493429-458D-4874-ADD6-646CD9008A6D}" type="datetimeFigureOut">
              <a:rPr lang="zh-CN" altLang="en-US" smtClean="0"/>
              <a:t>2025/7/1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74C6504-2B40-4D0D-8BCD-D1B23FBFA72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18608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altLang="zh-CN" sz="1200" b="0" i="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5D9ECAD-EBCD-4F63-9E3A-CB69461B4542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971246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6103609-2AD7-33ED-69EF-EA4BFDDDCAD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8A6B391-55EC-D90D-DFDC-D157849AD24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F123A88-302B-CF0E-08A5-9C84765602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DB88A-D495-45BB-A49E-1FE9696A1926}" type="datetimeFigureOut">
              <a:rPr lang="zh-CN" altLang="en-US" smtClean="0"/>
              <a:t>2025/7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AC7CFAF-E1BC-30E1-90DC-B323D99E84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A1C6CB9-E4D2-0312-C0D8-909FB75721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E84FB-9B57-48C2-B679-797ECC0AC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51091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43B4352-C38F-0638-58E1-C769680C43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A51879B-FB4B-61B5-2F04-79E9D3E2DC0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305AC23-6A8F-982F-8372-60988C1EDA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DB88A-D495-45BB-A49E-1FE9696A1926}" type="datetimeFigureOut">
              <a:rPr lang="zh-CN" altLang="en-US" smtClean="0"/>
              <a:t>2025/7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7132049-BF6A-96FC-7A6D-05CC5027BD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2071E4A-6413-7625-2274-BD174C3A2F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E84FB-9B57-48C2-B679-797ECC0AC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97322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4FFCBF95-FF69-5AE9-8FE9-2C369FB3F5B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72415D2-1A5D-892F-8B97-DF9263E8B8F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BF44BDD-7221-5ACF-86D3-DA57DA2483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DB88A-D495-45BB-A49E-1FE9696A1926}" type="datetimeFigureOut">
              <a:rPr lang="zh-CN" altLang="en-US" smtClean="0"/>
              <a:t>2025/7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BE218D1-F36A-3D40-3A2B-35EEEE48D9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B67EC40-123E-E11E-1A90-74B20BEB5D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E84FB-9B57-48C2-B679-797ECC0AC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30500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A8CEE37-FFFA-7BF6-3294-69380CF4EA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08FC28B-3C9F-2CA5-83AA-A1AE4A32B47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A411162-6007-69BA-C19E-3428564424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DB88A-D495-45BB-A49E-1FE9696A1926}" type="datetimeFigureOut">
              <a:rPr lang="zh-CN" altLang="en-US" smtClean="0"/>
              <a:t>2025/7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83B1317-C9DD-70DB-779D-E675DFCAC7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B09F7A0-57F1-EB3E-A286-F40A883E5B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E84FB-9B57-48C2-B679-797ECC0AC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11129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60B0D87-ACFD-0946-88E0-59C2240DE3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C7500D9-B789-E5AB-AF84-2AE94D7877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08B8B26-F36C-079F-13D5-AA5B03AFBB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DB88A-D495-45BB-A49E-1FE9696A1926}" type="datetimeFigureOut">
              <a:rPr lang="zh-CN" altLang="en-US" smtClean="0"/>
              <a:t>2025/7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C4B5742-F152-8878-5645-2B4852D194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800A37D-5D46-AA6D-1159-09EB11E7E4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E84FB-9B57-48C2-B679-797ECC0AC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49733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B057D70-8E62-DA46-0631-2BCDD6FE87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E418E80-3382-FE98-501B-980877881CF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3CD9BA3-2E50-006A-8D3E-DBA27A4E727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485922A-AB19-C3B1-7DD6-B9477FC99A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DB88A-D495-45BB-A49E-1FE9696A1926}" type="datetimeFigureOut">
              <a:rPr lang="zh-CN" altLang="en-US" smtClean="0"/>
              <a:t>2025/7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DE1902D-8592-4447-8F2B-33E6A21A79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6C54CED-601E-FA10-BFA5-5ACFDD26EC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E84FB-9B57-48C2-B679-797ECC0AC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55215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4653E65-C4AB-9705-F818-9A29FA388B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06F0510-874C-C675-EB55-B1ACA8DDC2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C4A8E28-5A6A-65CB-C508-DDBC373E89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360CE45D-12D8-DF34-1A60-59EE13D8C97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5A511FE0-E930-DFA3-267B-B997D605E82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76BB45D8-0F3E-DBD0-7940-6AC2180DCA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DB88A-D495-45BB-A49E-1FE9696A1926}" type="datetimeFigureOut">
              <a:rPr lang="zh-CN" altLang="en-US" smtClean="0"/>
              <a:t>2025/7/1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51794B2-543C-8A64-1D77-8DA169B53E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431596FE-C5B6-98EF-E127-90D14AC639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E84FB-9B57-48C2-B679-797ECC0AC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99702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2AB0C3A-D9A1-39D2-59F8-359CF3FBAA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88A0BD4D-632B-820B-0320-3E34968578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DB88A-D495-45BB-A49E-1FE9696A1926}" type="datetimeFigureOut">
              <a:rPr lang="zh-CN" altLang="en-US" smtClean="0"/>
              <a:t>2025/7/1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3B6779C0-D8C7-7641-34E4-6877E7C623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5700AF78-6BCE-C263-7F0D-341AD25905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E84FB-9B57-48C2-B679-797ECC0AC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24727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519B4458-A001-41A4-DCB3-9AE32E6C01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DB88A-D495-45BB-A49E-1FE9696A1926}" type="datetimeFigureOut">
              <a:rPr lang="zh-CN" altLang="en-US" smtClean="0"/>
              <a:t>2025/7/1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2532381E-EDD2-9662-CD11-2C1EB6E205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E10E63E4-888E-CB44-3326-A7C451CA8F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E84FB-9B57-48C2-B679-797ECC0AC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54327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00F4433-F832-8EC8-9742-10B3103154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7212963-8D86-C1F3-6A49-3E1D401AC86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4E6A11D-5229-9740-E271-3F5AD01894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6545BD1-E782-78C7-4793-CF73C93D48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DB88A-D495-45BB-A49E-1FE9696A1926}" type="datetimeFigureOut">
              <a:rPr lang="zh-CN" altLang="en-US" smtClean="0"/>
              <a:t>2025/7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E0F99EE-748E-0ABF-CAF2-FA71AAA206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CA1354A-EBAC-A17A-E946-8711EF415D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E84FB-9B57-48C2-B679-797ECC0AC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14365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19340F1-2E02-BD0D-D7E6-3F1223FC0A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C4AB662C-1CE4-F246-9504-1468F3B6B1E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A6E5E06-DD55-A70C-679C-5BF22ADEEC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0E933F6-21BA-648B-FC4E-13DC0A4DAF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0DB88A-D495-45BB-A49E-1FE9696A1926}" type="datetimeFigureOut">
              <a:rPr lang="zh-CN" altLang="en-US" smtClean="0"/>
              <a:t>2025/7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565EBBC-CA54-C899-C8CA-9E0A5EFCA1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D2CC2B6-A261-B7AA-9415-708A246282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0E84FB-9B57-48C2-B679-797ECC0AC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93339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FF1956A2-4A24-08C4-8377-5AD5B3E4C5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A69EF16-29D3-5FB8-1C30-7346AAB8F3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59342B8-E67A-6979-0FD7-5A24DD49FE6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0DB88A-D495-45BB-A49E-1FE9696A1926}" type="datetimeFigureOut">
              <a:rPr lang="zh-CN" altLang="en-US" smtClean="0"/>
              <a:t>2025/7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AEFAC1E-E459-947C-E878-58960E8D764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4261601-B8B9-C47F-6D48-FFB85D216A5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0E84FB-9B57-48C2-B679-797ECC0AC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43654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B53337D0-649C-A86F-A0B4-7D7A13A0628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89861918"/>
              </p:ext>
            </p:extLst>
          </p:nvPr>
        </p:nvGraphicFramePr>
        <p:xfrm>
          <a:off x="850053" y="826347"/>
          <a:ext cx="10491894" cy="52832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154312">
                  <a:extLst>
                    <a:ext uri="{9D8B030D-6E8A-4147-A177-3AD203B41FA5}">
                      <a16:colId xmlns:a16="http://schemas.microsoft.com/office/drawing/2014/main" val="3156852985"/>
                    </a:ext>
                  </a:extLst>
                </a:gridCol>
                <a:gridCol w="760781">
                  <a:extLst>
                    <a:ext uri="{9D8B030D-6E8A-4147-A177-3AD203B41FA5}">
                      <a16:colId xmlns:a16="http://schemas.microsoft.com/office/drawing/2014/main" val="652612003"/>
                    </a:ext>
                  </a:extLst>
                </a:gridCol>
                <a:gridCol w="1426464">
                  <a:extLst>
                    <a:ext uri="{9D8B030D-6E8A-4147-A177-3AD203B41FA5}">
                      <a16:colId xmlns:a16="http://schemas.microsoft.com/office/drawing/2014/main" val="2643172623"/>
                    </a:ext>
                  </a:extLst>
                </a:gridCol>
                <a:gridCol w="2442302">
                  <a:extLst>
                    <a:ext uri="{9D8B030D-6E8A-4147-A177-3AD203B41FA5}">
                      <a16:colId xmlns:a16="http://schemas.microsoft.com/office/drawing/2014/main" val="2479476359"/>
                    </a:ext>
                  </a:extLst>
                </a:gridCol>
                <a:gridCol w="4708035">
                  <a:extLst>
                    <a:ext uri="{9D8B030D-6E8A-4147-A177-3AD203B41FA5}">
                      <a16:colId xmlns:a16="http://schemas.microsoft.com/office/drawing/2014/main" val="2778883286"/>
                    </a:ext>
                  </a:extLst>
                </a:gridCol>
              </a:tblGrid>
              <a:tr h="577355">
                <a:tc gridSpan="4">
                  <a:txBody>
                    <a:bodyPr/>
                    <a:lstStyle/>
                    <a:p>
                      <a:pPr algn="l"/>
                      <a:r>
                        <a:rPr lang="en-GB" altLang="zh-CN" sz="10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able S1. </a:t>
                      </a:r>
                      <a:r>
                        <a:rPr lang="en-US" altLang="zh-CN" sz="10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isinfectants commonly used in prawn aquaculture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l"/>
                      <a:endParaRPr lang="zh-CN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l"/>
                      <a:endParaRPr lang="zh-CN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l"/>
                      <a:endParaRPr lang="zh-CN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9388071"/>
                  </a:ext>
                </a:extLst>
              </a:tr>
              <a:tr h="577355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infectants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0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osage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fect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xicity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erences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36744552"/>
                  </a:ext>
                </a:extLst>
              </a:tr>
              <a:tr h="85417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eracetic acid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0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 mg/L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0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 Purify surface water of infectious spores of the crayfish plague.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act causes mild irritation to the animal's skin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ussila J.; Makkonen J.; Kokko H. Peracetic acid (PAA) treatment is an effective disinfectant against crayfish plague (Aphanomyces </a:t>
                      </a:r>
                      <a:r>
                        <a:rPr lang="en-US" altLang="zh-CN" sz="1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taci</a:t>
                      </a: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 spores in aquaculture. Aquaculture, 2011, 320(1), 37-42.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31101101"/>
                  </a:ext>
                </a:extLst>
              </a:tr>
              <a:tr h="854170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0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ormaldehyde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0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5 g/m</a:t>
                      </a:r>
                      <a:r>
                        <a:rPr lang="en-US" altLang="zh-CN" sz="1000" b="0" i="0" kern="1200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altLang="zh-CN" sz="10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  <a:p>
                      <a:pPr algn="l"/>
                      <a:r>
                        <a:rPr lang="en-US" altLang="zh-CN" sz="10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 g/m</a:t>
                      </a:r>
                      <a:r>
                        <a:rPr lang="en-US" altLang="zh-CN" sz="1000" b="0" i="0" kern="1200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</a:t>
                      </a:r>
                      <a:endParaRPr lang="zh-CN" altLang="en-US" sz="1000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0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ffectively reduce the infection of embryos.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maldehyde might cause cancer or have potentially adverse effects on the aquatic environment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eng S.; Jiang W. P.; Liu S. L.; Chi M. L.; Zheng J. B.; Liu Y. N.; et al. Effects of disinfectants, sponge densities, water circulation rates, and vibration frequency on the artificial incubation of </a:t>
                      </a:r>
                      <a:r>
                        <a:rPr lang="en-US" altLang="zh-CN" sz="1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dclaw</a:t>
                      </a: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rayfish embryos. Aquaculture, 2023, 570.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81797709"/>
                  </a:ext>
                </a:extLst>
              </a:tr>
              <a:tr h="854170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eaching powder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0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8 g/m</a:t>
                      </a:r>
                      <a:r>
                        <a:rPr lang="en-US" altLang="zh-CN" sz="1000" b="0" i="0" kern="1200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altLang="zh-CN" sz="10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  <a:p>
                      <a:pPr algn="l"/>
                      <a:r>
                        <a:rPr lang="en-US" altLang="zh-CN" sz="10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 g/m</a:t>
                      </a:r>
                      <a:r>
                        <a:rPr lang="en-US" altLang="zh-CN" sz="1000" b="0" i="0" kern="1200" baseline="30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</a:t>
                      </a:r>
                      <a:endParaRPr lang="zh-CN" altLang="en-US" sz="1000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fectively control the spread of pathogens.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use abnormal proliferation of bacterial groups in water bodies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ang G. S.; Yan Y.; Li P. S.; Xie J. J.; Xu W. J.; Zhang D. M.; et al. Effects of bleaching powder disinfection for source water of shrimp farming on bacterial community. </a:t>
                      </a:r>
                      <a:r>
                        <a:rPr lang="en-US" altLang="zh-CN" sz="1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ceanologia</a:t>
                      </a: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et </a:t>
                      </a:r>
                      <a:r>
                        <a:rPr lang="en-US" altLang="zh-CN" sz="1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imnologia</a:t>
                      </a: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inica, 2024, 55(01), 202-212. (In </a:t>
                      </a:r>
                      <a:r>
                        <a:rPr lang="en-US" altLang="zh-CN" sz="1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inese</a:t>
                      </a: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150018969"/>
                  </a:ext>
                </a:extLst>
              </a:tr>
              <a:tr h="1565980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0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ovidone-iodine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 mg/m</a:t>
                      </a:r>
                      <a:r>
                        <a:rPr lang="en-US" altLang="zh-CN" sz="10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 </a:t>
                      </a:r>
                      <a:r>
                        <a:rPr lang="en-US" altLang="zh-CN" sz="10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 75</a:t>
                      </a: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/m</a:t>
                      </a:r>
                      <a:r>
                        <a:rPr lang="en-US" altLang="zh-CN" sz="10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 </a:t>
                      </a:r>
                      <a:endParaRPr lang="zh-CN" altLang="en-US" sz="1000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0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ffective against bacteria, fungi, parasites and certain spore forms.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0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he potential to </a:t>
                      </a: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gatively impact the immunity of crustaceans, thereby reducing their resistance to viral and bacterial diseases.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u G.; Zhou Q. L.; Gou X. L.; Ji C.; Mo Z. Q.; Dan X. M. The prevention of povidone iodine to </a:t>
                      </a:r>
                      <a:r>
                        <a:rPr lang="en-US" altLang="zh-CN" sz="1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itopenaeus</a:t>
                      </a: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zh-CN" sz="1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nnamei</a:t>
                      </a: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HNS. Journal of Aquaculture, 2016, 37(10), 23-28. (In </a:t>
                      </a:r>
                      <a:r>
                        <a:rPr lang="en-US" altLang="zh-CN" sz="1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inese</a:t>
                      </a: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  <a:p>
                      <a:pPr algn="l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 X. C.; Zhu F,; Jin Q. R. Antibiotics and chemical disease-control agents reduce innate disease resistance in crayfish. Fish &amp; shellfish immunology, 2019, 86, 169-178.</a:t>
                      </a:r>
                    </a:p>
                    <a:p>
                      <a:pPr algn="l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9280831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37068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4AB7E057-DD63-D888-1B41-254D047E48A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84883419"/>
              </p:ext>
            </p:extLst>
          </p:nvPr>
        </p:nvGraphicFramePr>
        <p:xfrm>
          <a:off x="781385" y="668866"/>
          <a:ext cx="10629229" cy="488357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216748">
                  <a:extLst>
                    <a:ext uri="{9D8B030D-6E8A-4147-A177-3AD203B41FA5}">
                      <a16:colId xmlns:a16="http://schemas.microsoft.com/office/drawing/2014/main" val="3156852985"/>
                    </a:ext>
                  </a:extLst>
                </a:gridCol>
                <a:gridCol w="4537885">
                  <a:extLst>
                    <a:ext uri="{9D8B030D-6E8A-4147-A177-3AD203B41FA5}">
                      <a16:colId xmlns:a16="http://schemas.microsoft.com/office/drawing/2014/main" val="2479476359"/>
                    </a:ext>
                  </a:extLst>
                </a:gridCol>
                <a:gridCol w="4874596">
                  <a:extLst>
                    <a:ext uri="{9D8B030D-6E8A-4147-A177-3AD203B41FA5}">
                      <a16:colId xmlns:a16="http://schemas.microsoft.com/office/drawing/2014/main" val="248379758"/>
                    </a:ext>
                  </a:extLst>
                </a:gridCol>
              </a:tblGrid>
              <a:tr h="688225">
                <a:tc gridSpan="2">
                  <a:txBody>
                    <a:bodyPr/>
                    <a:lstStyle/>
                    <a:p>
                      <a:pPr algn="l"/>
                      <a:r>
                        <a:rPr lang="en-GB" altLang="zh-CN" sz="10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able S2. </a:t>
                      </a:r>
                      <a:r>
                        <a:rPr lang="en-US" altLang="zh-CN" sz="10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isinfectants with dangerous feedback  for humans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l"/>
                      <a:endParaRPr lang="zh-CN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9388071"/>
                  </a:ext>
                </a:extLst>
              </a:tr>
              <a:tr h="688225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infectants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isks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erences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36744552"/>
                  </a:ext>
                </a:extLst>
              </a:tr>
              <a:tr h="1018197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orine</a:t>
                      </a:r>
                      <a:endParaRPr lang="en-US" altLang="zh-CN" sz="1000" b="0" i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alogenated acetic acids (HAA) formed by the reaction of chlorine disinfectants with natural organic matter present in water are genotoxic/cytotoxic in primary human lymphocytes and can induce chromosomal aberrations in human lymphocytes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uisa F. E. H.; Luz S. H. G.; Elizabeth L. V.; Ingrid R. C.; Diana S. T.; Silvio C. V.; et al. Genotoxic and clastogenic effects of </a:t>
                      </a:r>
                      <a:r>
                        <a:rPr lang="en-US" altLang="zh-CN" sz="1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nohaloacetic</a:t>
                      </a: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cid drinking water disinfection by-products in primary human lymphocytes. Water Research, 2013, 47(10), 3282-3290.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31101101"/>
                  </a:ext>
                </a:extLst>
              </a:tr>
              <a:tr h="735365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odine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ihalomethanes iodide produced by iodine disinfectants can increase the risk of rectal cancer in humans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rald B.; Peter R.; John V. Case control study of the geographic variability of exposure to disinfectant byproducts and risk for rectal cancer. International Journal of Health Geographics, 2007, 6(1), 18.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81797709"/>
                  </a:ext>
                </a:extLst>
              </a:tr>
              <a:tr h="735365">
                <a:tc>
                  <a:txBody>
                    <a:bodyPr/>
                    <a:lstStyle/>
                    <a:p>
                      <a:pPr algn="l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zone (O</a:t>
                      </a:r>
                      <a:r>
                        <a:rPr lang="en-US" altLang="zh-CN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romate formed by the reaction of ozone with organic matter is a pollutant that increases the risk of cancer in humans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SEPA. 2009, Drinking Water Contaminants.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150018969"/>
                  </a:ext>
                </a:extLst>
              </a:tr>
              <a:tr h="1018197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000" b="0" i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eracetic acid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A treatment in brackish water systems produced up to 360 </a:t>
                      </a:r>
                      <a:r>
                        <a:rPr lang="en-US" altLang="zh-CN" sz="1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μg</a:t>
                      </a: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L of THMs and 230 </a:t>
                      </a:r>
                      <a:r>
                        <a:rPr lang="en-US" altLang="zh-CN" sz="10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μg</a:t>
                      </a: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L of HAAs.</a:t>
                      </a:r>
                      <a:r>
                        <a:rPr lang="zh-CN" alt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AA are genotoxic/cytotoxic in primary human lymphocytes and can induce chromosomal aberrations in human lymphocytes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vidson J,; Summerfelt S.; Straus L. D.; Schrader K. K.; Christopher G. Evaluating the effects of prolonged peracetic acid dosing on water quality and rainbow trout Oncorhynchus mykiss performance in recirculation aquaculture systems. Aquacultural Engineering, 2018, 84, 117-127.</a:t>
                      </a:r>
                      <a:endParaRPr lang="zh-CN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9280831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945739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673</Words>
  <Application>Microsoft Office PowerPoint</Application>
  <PresentationFormat>宽屏</PresentationFormat>
  <Paragraphs>46</Paragraphs>
  <Slides>2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天慧 焦</dc:creator>
  <cp:lastModifiedBy>天慧 焦</cp:lastModifiedBy>
  <cp:revision>5</cp:revision>
  <dcterms:created xsi:type="dcterms:W3CDTF">2025-07-15T18:35:50Z</dcterms:created>
  <dcterms:modified xsi:type="dcterms:W3CDTF">2025-07-16T12:41:44Z</dcterms:modified>
</cp:coreProperties>
</file>